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57046-AE9A-498A-BBDD-FAAE9E1EA8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3A480-451D-472A-8D20-F7748152F7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340AE-F0E4-446D-8FFC-35D011FF72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4E3FA-1FE3-4944-84F6-AF7778D2C5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2E0CE-6DBE-4D40-B6FE-2C452DF35F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C8650-6AEE-451B-896B-FEF64AC0E9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99129-597F-48B6-844B-4451173F9C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4F21B-89C3-436C-A4F8-5E02286F06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E0334-25E6-4E12-901B-3401CFEE53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2C513-FC3B-4058-A809-E0FECB6D62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85F40-1BE7-4B8A-AF1D-A59162AFFF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65A8D-62E5-4BD4-AF39-D63AE07A87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B7BB90-B0AD-458E-8578-5792191E224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8" descr=""/>
          <p:cNvPicPr/>
          <p:nvPr/>
        </p:nvPicPr>
        <p:blipFill>
          <a:blip r:embed="rId1"/>
          <a:stretch/>
        </p:blipFill>
        <p:spPr>
          <a:xfrm>
            <a:off x="1500120" y="712800"/>
            <a:ext cx="5437080" cy="4183200"/>
          </a:xfrm>
          <a:prstGeom prst="rect">
            <a:avLst/>
          </a:prstGeom>
          <a:ln w="0">
            <a:noFill/>
          </a:ln>
        </p:spPr>
      </p:pic>
      <p:sp>
        <p:nvSpPr>
          <p:cNvPr id="42" name="TextBox 9"/>
          <p:cNvSpPr/>
          <p:nvPr/>
        </p:nvSpPr>
        <p:spPr>
          <a:xfrm>
            <a:off x="642960" y="5000760"/>
            <a:ext cx="767412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1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comparison of the microarray and qPCR assay data, based on the ratio between sample and control (S/C) in LTH and IR29. Total 24 DEGs  were chosen, representing 240 comparisons when one gene covers 10 different times of S/C.  Line shown represent the orthogonal fit to the data and correlation (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was shown in the inset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tingwing</cp:lastModifiedBy>
  <dcterms:modified xsi:type="dcterms:W3CDTF">2012-07-23T08:21:23Z</dcterms:modified>
  <cp:revision>23</cp:revision>
  <dc:subject/>
  <dc:title>幻灯片 1</dc:title>
</cp:coreProperties>
</file>